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56" r:id="rId3"/>
    <p:sldId id="260" r:id="rId4"/>
    <p:sldId id="261" r:id="rId5"/>
    <p:sldId id="262" r:id="rId6"/>
  </p:sldIdLst>
  <p:sldSz cx="6858000" cy="9906000" type="A4"/>
  <p:notesSz cx="6858000" cy="9144000"/>
  <p:defaultTextStyle>
    <a:defPPr>
      <a:defRPr lang="da-DK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llemlayout 2 - Markering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1"/>
    <p:restoredTop sz="94674"/>
  </p:normalViewPr>
  <p:slideViewPr>
    <p:cSldViewPr snapToGrid="0" snapToObjects="1">
      <p:cViewPr varScale="1">
        <p:scale>
          <a:sx n="86" d="100"/>
          <a:sy n="86" d="100"/>
        </p:scale>
        <p:origin x="3552" y="200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da-DK"/>
              <a:t>Klik for at redigere i masteren</a:t>
            </a:r>
          </a:p>
        </p:txBody>
      </p:sp>
      <p:sp>
        <p:nvSpPr>
          <p:cNvPr id="3" name="Undertitel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a-DK"/>
              <a:t>Klik for at redigere undertiteltypografien i masteren</a:t>
            </a:r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E19EE9-73B9-894D-B7C4-E6D535FA612D}" type="datetimeFigureOut">
              <a:rPr lang="da-DK" smtClean="0"/>
              <a:t>15.04.2021</a:t>
            </a:fld>
            <a:endParaRPr lang="da-DK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dias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62CA51-3D5E-F64F-96FB-843694A17906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6917747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og lodret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i masteren</a:t>
            </a:r>
          </a:p>
        </p:txBody>
      </p:sp>
      <p:sp>
        <p:nvSpPr>
          <p:cNvPr id="3" name="Pladsholder til lodret tite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E19EE9-73B9-894D-B7C4-E6D535FA612D}" type="datetimeFigureOut">
              <a:rPr lang="da-DK" smtClean="0"/>
              <a:t>15.04.2021</a:t>
            </a:fld>
            <a:endParaRPr lang="da-DK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dias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62CA51-3D5E-F64F-96FB-843694A17906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59871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et titel og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et titel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da-DK"/>
              <a:t>Klik for at redigere i masteren</a:t>
            </a:r>
          </a:p>
        </p:txBody>
      </p:sp>
      <p:sp>
        <p:nvSpPr>
          <p:cNvPr id="3" name="Pladsholder til lodret titel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E19EE9-73B9-894D-B7C4-E6D535FA612D}" type="datetimeFigureOut">
              <a:rPr lang="da-DK" smtClean="0"/>
              <a:t>15.04.2021</a:t>
            </a:fld>
            <a:endParaRPr lang="da-DK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dias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62CA51-3D5E-F64F-96FB-843694A17906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5471412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og indholdsobjek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i masteren</a:t>
            </a:r>
          </a:p>
        </p:txBody>
      </p:sp>
      <p:sp>
        <p:nvSpPr>
          <p:cNvPr id="3" name="Pladsholder til indhol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E19EE9-73B9-894D-B7C4-E6D535FA612D}" type="datetimeFigureOut">
              <a:rPr lang="da-DK" smtClean="0"/>
              <a:t>15.04.2021</a:t>
            </a:fld>
            <a:endParaRPr lang="da-DK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dias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62CA51-3D5E-F64F-96FB-843694A17906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9578711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fsnitsoversk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a-DK"/>
              <a:t>Klik for at redigere i masteren</a:t>
            </a:r>
          </a:p>
        </p:txBody>
      </p:sp>
      <p:sp>
        <p:nvSpPr>
          <p:cNvPr id="3" name="Pladsholder til tekst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a-DK"/>
              <a:t>Klik for at redigere teksttypografierne i masteren</a:t>
            </a:r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E19EE9-73B9-894D-B7C4-E6D535FA612D}" type="datetimeFigureOut">
              <a:rPr lang="da-DK" smtClean="0"/>
              <a:t>15.04.2021</a:t>
            </a:fld>
            <a:endParaRPr lang="da-DK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dias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62CA51-3D5E-F64F-96FB-843694A17906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0038232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o indholdsobjekt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i masteren</a:t>
            </a:r>
          </a:p>
        </p:txBody>
      </p:sp>
      <p:sp>
        <p:nvSpPr>
          <p:cNvPr id="3" name="Pladsholder til indhold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4" name="Pladsholder til indhold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5" name="Pladsholder til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E19EE9-73B9-894D-B7C4-E6D535FA612D}" type="datetimeFigureOut">
              <a:rPr lang="da-DK" smtClean="0"/>
              <a:t>15.04.2021</a:t>
            </a:fld>
            <a:endParaRPr lang="da-DK"/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Pladsholder til dias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62CA51-3D5E-F64F-96FB-843694A17906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40804724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Sammenlign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da-DK"/>
              <a:t>Klik for at redigere i masteren</a:t>
            </a:r>
          </a:p>
        </p:txBody>
      </p:sp>
      <p:sp>
        <p:nvSpPr>
          <p:cNvPr id="3" name="Pladsholder til tekst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a-DK"/>
              <a:t>Klik for at redigere teksttypografierne i masteren</a:t>
            </a:r>
          </a:p>
        </p:txBody>
      </p:sp>
      <p:sp>
        <p:nvSpPr>
          <p:cNvPr id="4" name="Pladsholder til indhold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5" name="Pladsholder til tekst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a-DK"/>
              <a:t>Klik for at redigere teksttypografierne i masteren</a:t>
            </a:r>
          </a:p>
        </p:txBody>
      </p:sp>
      <p:sp>
        <p:nvSpPr>
          <p:cNvPr id="6" name="Pladsholder til indhold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7" name="Pladsholder til dato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E19EE9-73B9-894D-B7C4-E6D535FA612D}" type="datetimeFigureOut">
              <a:rPr lang="da-DK" smtClean="0"/>
              <a:t>15.04.2021</a:t>
            </a:fld>
            <a:endParaRPr lang="da-DK"/>
          </a:p>
        </p:txBody>
      </p:sp>
      <p:sp>
        <p:nvSpPr>
          <p:cNvPr id="8" name="Pladsholder til sidefod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9" name="Pladsholder til dias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62CA51-3D5E-F64F-96FB-843694A17906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7922376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Ku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i masteren</a:t>
            </a:r>
          </a:p>
        </p:txBody>
      </p:sp>
      <p:sp>
        <p:nvSpPr>
          <p:cNvPr id="3" name="Pladsholder til dato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E19EE9-73B9-894D-B7C4-E6D535FA612D}" type="datetimeFigureOut">
              <a:rPr lang="da-DK" smtClean="0"/>
              <a:t>15.04.2021</a:t>
            </a:fld>
            <a:endParaRPr lang="da-DK"/>
          </a:p>
        </p:txBody>
      </p:sp>
      <p:sp>
        <p:nvSpPr>
          <p:cNvPr id="4" name="Pladsholder til sidefod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5" name="Pladsholder til dias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62CA51-3D5E-F64F-96FB-843694A17906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4361352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dato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E19EE9-73B9-894D-B7C4-E6D535FA612D}" type="datetimeFigureOut">
              <a:rPr lang="da-DK" smtClean="0"/>
              <a:t>15.04.2021</a:t>
            </a:fld>
            <a:endParaRPr lang="da-DK"/>
          </a:p>
        </p:txBody>
      </p:sp>
      <p:sp>
        <p:nvSpPr>
          <p:cNvPr id="3" name="Pladsholder til sidefod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4" name="Pladsholder til dias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62CA51-3D5E-F64F-96FB-843694A17906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5540588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dhold med billed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a-DK"/>
              <a:t>Klik for at redigere i masteren</a:t>
            </a:r>
          </a:p>
        </p:txBody>
      </p:sp>
      <p:sp>
        <p:nvSpPr>
          <p:cNvPr id="3" name="Pladsholder til indhold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4" name="Pladsholder til tekst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a-DK"/>
              <a:t>Klik for at redigere teksttypografierne i masteren</a:t>
            </a:r>
          </a:p>
        </p:txBody>
      </p:sp>
      <p:sp>
        <p:nvSpPr>
          <p:cNvPr id="5" name="Pladsholder til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E19EE9-73B9-894D-B7C4-E6D535FA612D}" type="datetimeFigureOut">
              <a:rPr lang="da-DK" smtClean="0"/>
              <a:t>15.04.2021</a:t>
            </a:fld>
            <a:endParaRPr lang="da-DK"/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Pladsholder til dias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62CA51-3D5E-F64F-96FB-843694A17906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40351681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lede med billed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a-DK"/>
              <a:t>Klik for at redigere i masteren</a:t>
            </a:r>
          </a:p>
        </p:txBody>
      </p:sp>
      <p:sp>
        <p:nvSpPr>
          <p:cNvPr id="3" name="Pladsholder til billede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a-DK"/>
          </a:p>
        </p:txBody>
      </p:sp>
      <p:sp>
        <p:nvSpPr>
          <p:cNvPr id="4" name="Pladsholder til tekst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a-DK"/>
              <a:t>Klik for at redigere teksttypografierne i masteren</a:t>
            </a:r>
          </a:p>
        </p:txBody>
      </p:sp>
      <p:sp>
        <p:nvSpPr>
          <p:cNvPr id="5" name="Pladsholder til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E19EE9-73B9-894D-B7C4-E6D535FA612D}" type="datetimeFigureOut">
              <a:rPr lang="da-DK" smtClean="0"/>
              <a:t>15.04.2021</a:t>
            </a:fld>
            <a:endParaRPr lang="da-DK"/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Pladsholder til dias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62CA51-3D5E-F64F-96FB-843694A17906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4623772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titel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a-DK"/>
              <a:t>Klik for at redigere i masteren</a:t>
            </a:r>
          </a:p>
        </p:txBody>
      </p:sp>
      <p:sp>
        <p:nvSpPr>
          <p:cNvPr id="3" name="Pladsholder til tekst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E19EE9-73B9-894D-B7C4-E6D535FA612D}" type="datetimeFigureOut">
              <a:rPr lang="da-DK" smtClean="0"/>
              <a:t>15.04.2021</a:t>
            </a:fld>
            <a:endParaRPr lang="da-DK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a-DK"/>
          </a:p>
        </p:txBody>
      </p:sp>
      <p:sp>
        <p:nvSpPr>
          <p:cNvPr id="6" name="Pladsholder til diasnumm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62CA51-3D5E-F64F-96FB-843694A17906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0993782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a-DK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Pladsholder til indhold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marL="0" indent="0">
              <a:buNone/>
            </a:pPr>
            <a:r>
              <a:rPr lang="en-US" sz="1400" dirty="0"/>
              <a:t>Arterial stiffness and</a:t>
            </a:r>
            <a:r>
              <a:rPr lang="en-GB" sz="1400" dirty="0"/>
              <a:t> progression of</a:t>
            </a:r>
            <a:r>
              <a:rPr lang="en-US" sz="1400" dirty="0"/>
              <a:t> cerebral white matter lesions in asymptomatic patients with type 2 diabetes</a:t>
            </a:r>
            <a:r>
              <a:rPr lang="da-DK" sz="1400" dirty="0"/>
              <a:t> : a 5-year </a:t>
            </a:r>
            <a:r>
              <a:rPr lang="da-DK" sz="1400" dirty="0" err="1"/>
              <a:t>cohort</a:t>
            </a:r>
            <a:r>
              <a:rPr lang="da-DK" sz="1400" dirty="0"/>
              <a:t> </a:t>
            </a:r>
            <a:r>
              <a:rPr lang="da-DK" sz="1400" dirty="0" err="1"/>
              <a:t>study</a:t>
            </a:r>
            <a:endParaRPr lang="da-DK" sz="1400" dirty="0"/>
          </a:p>
          <a:p>
            <a:pPr marL="0" indent="0">
              <a:buNone/>
            </a:pPr>
            <a:r>
              <a:rPr lang="en-US" sz="1400" dirty="0"/>
              <a:t>K.L. Funck, E. </a:t>
            </a:r>
            <a:r>
              <a:rPr lang="en-US" sz="1400" dirty="0" err="1"/>
              <a:t>Laugesen</a:t>
            </a:r>
            <a:r>
              <a:rPr lang="en-US" sz="1400" dirty="0"/>
              <a:t>, P. </a:t>
            </a:r>
            <a:r>
              <a:rPr lang="en-US" sz="1400" dirty="0" err="1"/>
              <a:t>Høyem</a:t>
            </a:r>
            <a:r>
              <a:rPr lang="en-US" sz="1400" dirty="0"/>
              <a:t>, B. </a:t>
            </a:r>
            <a:r>
              <a:rPr lang="en-US" sz="1400" dirty="0" err="1"/>
              <a:t>Staunsbøll-Grøn</a:t>
            </a:r>
            <a:r>
              <a:rPr lang="en-US" sz="1400" dirty="0"/>
              <a:t>, W.Y. Kim, L. </a:t>
            </a:r>
            <a:r>
              <a:rPr lang="en-US" sz="1400" dirty="0" err="1"/>
              <a:t>Østergaard</a:t>
            </a:r>
            <a:r>
              <a:rPr lang="en-US" sz="1400" dirty="0"/>
              <a:t>, D. </a:t>
            </a:r>
            <a:r>
              <a:rPr lang="en-US" sz="1400" dirty="0" err="1"/>
              <a:t>Zeidler</a:t>
            </a:r>
            <a:r>
              <a:rPr lang="en-US" sz="1400" dirty="0"/>
              <a:t>, T.K. Hansen, C. Buhl, </a:t>
            </a:r>
            <a:r>
              <a:rPr lang="en-US" sz="1400" dirty="0" err="1"/>
              <a:t>P.L.Poulsen</a:t>
            </a:r>
            <a:r>
              <a:rPr lang="da-DK" sz="1400" dirty="0"/>
              <a:t>.</a:t>
            </a:r>
          </a:p>
          <a:p>
            <a:pPr marL="0" indent="0">
              <a:buNone/>
            </a:pPr>
            <a:endParaRPr lang="da-DK" sz="1400" dirty="0"/>
          </a:p>
          <a:p>
            <a:pPr marL="0" indent="0">
              <a:buNone/>
            </a:pPr>
            <a:endParaRPr lang="da-DK" sz="1400" dirty="0"/>
          </a:p>
          <a:p>
            <a:pPr marL="0" indent="0">
              <a:buNone/>
            </a:pPr>
            <a:endParaRPr lang="da-DK" sz="1400" dirty="0"/>
          </a:p>
          <a:p>
            <a:pPr marL="0" indent="0">
              <a:buNone/>
            </a:pPr>
            <a:endParaRPr lang="da-DK" sz="1400" dirty="0"/>
          </a:p>
        </p:txBody>
      </p:sp>
      <p:sp>
        <p:nvSpPr>
          <p:cNvPr id="5" name="Titel 1"/>
          <p:cNvSpPr txBox="1">
            <a:spLocks/>
          </p:cNvSpPr>
          <p:nvPr/>
        </p:nvSpPr>
        <p:spPr>
          <a:xfrm>
            <a:off x="514350" y="454889"/>
            <a:ext cx="5829300" cy="212336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4572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dirty="0">
                <a:latin typeface="Times New Roman"/>
                <a:cs typeface="Times New Roman"/>
              </a:rPr>
              <a:t>Supplementary material</a:t>
            </a:r>
          </a:p>
        </p:txBody>
      </p:sp>
    </p:spTree>
    <p:extLst>
      <p:ext uri="{BB962C8B-B14F-4D97-AF65-F5344CB8AC3E}">
        <p14:creationId xmlns:p14="http://schemas.microsoft.com/office/powerpoint/2010/main" val="346517738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kstfelt 3"/>
          <p:cNvSpPr txBox="1"/>
          <p:nvPr/>
        </p:nvSpPr>
        <p:spPr>
          <a:xfrm>
            <a:off x="2423458" y="586334"/>
            <a:ext cx="16656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articipant flow</a:t>
            </a:r>
          </a:p>
        </p:txBody>
      </p:sp>
      <p:sp>
        <p:nvSpPr>
          <p:cNvPr id="5" name="Tekstfelt 4"/>
          <p:cNvSpPr txBox="1"/>
          <p:nvPr/>
        </p:nvSpPr>
        <p:spPr>
          <a:xfrm>
            <a:off x="0" y="1156476"/>
            <a:ext cx="220434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dirty="0"/>
              <a:t>Baseline visit 2009-2011</a:t>
            </a:r>
          </a:p>
        </p:txBody>
      </p:sp>
      <p:sp>
        <p:nvSpPr>
          <p:cNvPr id="6" name="Tekstfelt 5"/>
          <p:cNvSpPr txBox="1"/>
          <p:nvPr/>
        </p:nvSpPr>
        <p:spPr>
          <a:xfrm>
            <a:off x="0" y="3762990"/>
            <a:ext cx="213001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dirty="0"/>
              <a:t>Follow-up visit 2014-16</a:t>
            </a:r>
          </a:p>
        </p:txBody>
      </p:sp>
      <p:sp>
        <p:nvSpPr>
          <p:cNvPr id="7" name="Tekstfelt 6"/>
          <p:cNvSpPr txBox="1"/>
          <p:nvPr/>
        </p:nvSpPr>
        <p:spPr>
          <a:xfrm>
            <a:off x="2250761" y="1156476"/>
            <a:ext cx="2011084" cy="41549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050" dirty="0"/>
              <a:t>100 patients with type 2 diabetes</a:t>
            </a:r>
          </a:p>
          <a:p>
            <a:r>
              <a:rPr lang="en-US" sz="1050" dirty="0"/>
              <a:t>100 controls</a:t>
            </a:r>
          </a:p>
        </p:txBody>
      </p:sp>
      <p:sp>
        <p:nvSpPr>
          <p:cNvPr id="8" name="Tekstfelt 7"/>
          <p:cNvSpPr txBox="1"/>
          <p:nvPr/>
        </p:nvSpPr>
        <p:spPr>
          <a:xfrm>
            <a:off x="2857617" y="3762990"/>
            <a:ext cx="797373" cy="41549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050" dirty="0"/>
              <a:t>63 patients</a:t>
            </a:r>
          </a:p>
          <a:p>
            <a:r>
              <a:rPr lang="en-US" sz="1050" dirty="0"/>
              <a:t>72 controls</a:t>
            </a:r>
          </a:p>
        </p:txBody>
      </p:sp>
      <p:sp>
        <p:nvSpPr>
          <p:cNvPr id="9" name="Tekstfelt 8"/>
          <p:cNvSpPr txBox="1"/>
          <p:nvPr/>
        </p:nvSpPr>
        <p:spPr>
          <a:xfrm>
            <a:off x="2842626" y="8001882"/>
            <a:ext cx="827354" cy="415498"/>
          </a:xfrm>
          <a:prstGeom prst="rect">
            <a:avLst/>
          </a:prstGeom>
          <a:noFill/>
          <a:ln w="38100" cmpd="sng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050" dirty="0"/>
              <a:t>45 patients </a:t>
            </a:r>
          </a:p>
          <a:p>
            <a:r>
              <a:rPr lang="en-US" sz="1050" dirty="0"/>
              <a:t>59 controls</a:t>
            </a:r>
          </a:p>
        </p:txBody>
      </p:sp>
      <p:sp>
        <p:nvSpPr>
          <p:cNvPr id="11" name="Tekstfelt 10"/>
          <p:cNvSpPr txBox="1"/>
          <p:nvPr/>
        </p:nvSpPr>
        <p:spPr>
          <a:xfrm>
            <a:off x="474443" y="7811571"/>
            <a:ext cx="1197864" cy="584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dirty="0"/>
              <a:t>Full data set</a:t>
            </a:r>
          </a:p>
          <a:p>
            <a:pPr algn="ctr"/>
            <a:endParaRPr lang="en-US" sz="1600" dirty="0"/>
          </a:p>
        </p:txBody>
      </p:sp>
      <p:sp>
        <p:nvSpPr>
          <p:cNvPr id="13" name="Tekstfelt 12"/>
          <p:cNvSpPr txBox="1"/>
          <p:nvPr/>
        </p:nvSpPr>
        <p:spPr>
          <a:xfrm>
            <a:off x="4380210" y="1690889"/>
            <a:ext cx="2326278" cy="186974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050" u="sng" dirty="0"/>
              <a:t>Dropout</a:t>
            </a:r>
          </a:p>
          <a:p>
            <a:r>
              <a:rPr lang="en-US" sz="1050" dirty="0"/>
              <a:t>37 patients</a:t>
            </a:r>
          </a:p>
          <a:p>
            <a:pPr marL="171450" indent="-171450">
              <a:buFont typeface="Wingdings" charset="2"/>
              <a:buChar char="§"/>
            </a:pPr>
            <a:r>
              <a:rPr lang="en-US" sz="1050" dirty="0"/>
              <a:t>Follow-up invitation rejected (n=24)</a:t>
            </a:r>
          </a:p>
          <a:p>
            <a:pPr marL="171450" indent="-171450">
              <a:buFont typeface="Wingdings" charset="2"/>
              <a:buChar char="§"/>
            </a:pPr>
            <a:r>
              <a:rPr lang="en-US" sz="1050" dirty="0"/>
              <a:t>No contact (n=6)</a:t>
            </a:r>
          </a:p>
          <a:p>
            <a:pPr marL="171450" indent="-171450">
              <a:buFont typeface="Wingdings" charset="2"/>
              <a:buChar char="§"/>
            </a:pPr>
            <a:r>
              <a:rPr lang="en-US" sz="1050" dirty="0"/>
              <a:t>GAD-positive diabetes (n=2)</a:t>
            </a:r>
          </a:p>
          <a:p>
            <a:pPr marL="171450" indent="-171450">
              <a:buFont typeface="Wingdings" charset="2"/>
              <a:buChar char="§"/>
            </a:pPr>
            <a:r>
              <a:rPr lang="en-US" sz="1050" dirty="0"/>
              <a:t>Death (n=5)</a:t>
            </a:r>
          </a:p>
          <a:p>
            <a:endParaRPr lang="en-US" sz="1050" dirty="0"/>
          </a:p>
          <a:p>
            <a:r>
              <a:rPr lang="en-US" sz="1050" dirty="0"/>
              <a:t>28 controls</a:t>
            </a:r>
          </a:p>
          <a:p>
            <a:pPr marL="171450" indent="-171450">
              <a:buFont typeface="Wingdings" charset="2"/>
              <a:buChar char="§"/>
            </a:pPr>
            <a:r>
              <a:rPr lang="en-US" sz="1050" dirty="0"/>
              <a:t>Follow-up invitation rejected (n=22)</a:t>
            </a:r>
          </a:p>
          <a:p>
            <a:pPr marL="171450" indent="-171450">
              <a:buFont typeface="Wingdings" charset="2"/>
              <a:buChar char="§"/>
            </a:pPr>
            <a:r>
              <a:rPr lang="en-US" sz="1050" dirty="0"/>
              <a:t>No contact (n=2)</a:t>
            </a:r>
          </a:p>
          <a:p>
            <a:pPr marL="171450" indent="-171450">
              <a:buFont typeface="Wingdings" charset="2"/>
              <a:buChar char="§"/>
            </a:pPr>
            <a:r>
              <a:rPr lang="en-US" sz="1050" dirty="0"/>
              <a:t>Death (m=4)</a:t>
            </a:r>
          </a:p>
        </p:txBody>
      </p:sp>
      <p:sp>
        <p:nvSpPr>
          <p:cNvPr id="14" name="Tekstfelt 13"/>
          <p:cNvSpPr txBox="1"/>
          <p:nvPr/>
        </p:nvSpPr>
        <p:spPr>
          <a:xfrm>
            <a:off x="4393034" y="5155313"/>
            <a:ext cx="2313454" cy="186974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en-US" sz="1050" u="sng" dirty="0"/>
          </a:p>
          <a:p>
            <a:r>
              <a:rPr lang="en-US" sz="1050" u="sng" dirty="0"/>
              <a:t>History of stroke/TIA at baseline</a:t>
            </a:r>
          </a:p>
          <a:p>
            <a:r>
              <a:rPr lang="en-US" sz="1050" dirty="0"/>
              <a:t>4 patients</a:t>
            </a:r>
          </a:p>
          <a:p>
            <a:endParaRPr lang="en-US" sz="1050" u="sng" dirty="0"/>
          </a:p>
          <a:p>
            <a:r>
              <a:rPr lang="en-US" sz="1050" u="sng" dirty="0"/>
              <a:t>Missing baseline PWV</a:t>
            </a:r>
          </a:p>
          <a:p>
            <a:r>
              <a:rPr lang="en-US" sz="1050" dirty="0"/>
              <a:t>2 patients</a:t>
            </a:r>
          </a:p>
          <a:p>
            <a:r>
              <a:rPr lang="en-US" sz="1050" dirty="0"/>
              <a:t>8 controls </a:t>
            </a:r>
          </a:p>
          <a:p>
            <a:endParaRPr lang="en-US" sz="1050" u="sng" dirty="0"/>
          </a:p>
          <a:p>
            <a:r>
              <a:rPr lang="en-US" sz="1050" u="sng" dirty="0"/>
              <a:t>Missing MRI at baseline or follow-up</a:t>
            </a:r>
          </a:p>
          <a:p>
            <a:r>
              <a:rPr lang="en-US" sz="1050" dirty="0"/>
              <a:t>12 patients</a:t>
            </a:r>
          </a:p>
          <a:p>
            <a:r>
              <a:rPr lang="en-US" sz="1050" dirty="0"/>
              <a:t>5 controls</a:t>
            </a:r>
          </a:p>
        </p:txBody>
      </p:sp>
      <p:cxnSp>
        <p:nvCxnSpPr>
          <p:cNvPr id="16" name="Lige forbindelse 15"/>
          <p:cNvCxnSpPr>
            <a:stCxn id="7" idx="2"/>
            <a:endCxn id="8" idx="0"/>
          </p:cNvCxnSpPr>
          <p:nvPr/>
        </p:nvCxnSpPr>
        <p:spPr>
          <a:xfrm>
            <a:off x="3256303" y="1571974"/>
            <a:ext cx="1" cy="2191016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" name="Lige forbindelse 16"/>
          <p:cNvCxnSpPr>
            <a:stCxn id="8" idx="2"/>
            <a:endCxn id="9" idx="0"/>
          </p:cNvCxnSpPr>
          <p:nvPr/>
        </p:nvCxnSpPr>
        <p:spPr>
          <a:xfrm flipH="1">
            <a:off x="3256303" y="4178488"/>
            <a:ext cx="1" cy="3823394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9" name="Lige forbindelse 18"/>
          <p:cNvCxnSpPr/>
          <p:nvPr/>
        </p:nvCxnSpPr>
        <p:spPr>
          <a:xfrm flipH="1">
            <a:off x="3256304" y="2625762"/>
            <a:ext cx="1123906" cy="1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0" name="Lige forbindelse 19"/>
          <p:cNvCxnSpPr/>
          <p:nvPr/>
        </p:nvCxnSpPr>
        <p:spPr>
          <a:xfrm flipH="1">
            <a:off x="3256304" y="6063984"/>
            <a:ext cx="1136730" cy="1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2" name="Tekstfelt 21"/>
          <p:cNvSpPr txBox="1"/>
          <p:nvPr/>
        </p:nvSpPr>
        <p:spPr>
          <a:xfrm>
            <a:off x="180614" y="217002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dirty="0" err="1"/>
              <a:t>Supplementary</a:t>
            </a:r>
            <a:r>
              <a:rPr lang="da-DK" dirty="0"/>
              <a:t> </a:t>
            </a:r>
            <a:r>
              <a:rPr lang="da-DK" dirty="0" err="1"/>
              <a:t>Figure</a:t>
            </a:r>
            <a:r>
              <a:rPr lang="da-DK" dirty="0"/>
              <a:t> 1</a:t>
            </a:r>
          </a:p>
        </p:txBody>
      </p:sp>
    </p:spTree>
    <p:extLst>
      <p:ext uri="{BB962C8B-B14F-4D97-AF65-F5344CB8AC3E}">
        <p14:creationId xmlns:p14="http://schemas.microsoft.com/office/powerpoint/2010/main" val="50509198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kstfelt 5"/>
          <p:cNvSpPr txBox="1"/>
          <p:nvPr/>
        </p:nvSpPr>
        <p:spPr>
          <a:xfrm>
            <a:off x="3877362" y="7065582"/>
            <a:ext cx="1846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da-DK" dirty="0"/>
          </a:p>
        </p:txBody>
      </p:sp>
      <p:pic>
        <p:nvPicPr>
          <p:cNvPr id="9" name="Billede 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257300"/>
            <a:ext cx="6858000" cy="7389432"/>
          </a:xfrm>
          <a:prstGeom prst="rect">
            <a:avLst/>
          </a:prstGeom>
        </p:spPr>
      </p:pic>
      <p:sp>
        <p:nvSpPr>
          <p:cNvPr id="10" name="Tekstfelt 9"/>
          <p:cNvSpPr txBox="1"/>
          <p:nvPr/>
        </p:nvSpPr>
        <p:spPr>
          <a:xfrm>
            <a:off x="0" y="642459"/>
            <a:ext cx="663339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aseline characteristics in participants attending versus not attending the follow-up visit</a:t>
            </a:r>
            <a:r>
              <a:rPr lang="da-DK" dirty="0"/>
              <a:t> </a:t>
            </a:r>
          </a:p>
        </p:txBody>
      </p:sp>
      <p:sp>
        <p:nvSpPr>
          <p:cNvPr id="11" name="Tekstfelt 10"/>
          <p:cNvSpPr txBox="1"/>
          <p:nvPr/>
        </p:nvSpPr>
        <p:spPr>
          <a:xfrm>
            <a:off x="0" y="273127"/>
            <a:ext cx="23317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dirty="0" err="1"/>
              <a:t>Supplementary</a:t>
            </a:r>
            <a:r>
              <a:rPr lang="da-DK" dirty="0"/>
              <a:t> </a:t>
            </a:r>
            <a:r>
              <a:rPr lang="da-DK" dirty="0" err="1"/>
              <a:t>Table</a:t>
            </a:r>
            <a:r>
              <a:rPr lang="da-DK" dirty="0"/>
              <a:t> 1</a:t>
            </a:r>
          </a:p>
        </p:txBody>
      </p:sp>
    </p:spTree>
    <p:extLst>
      <p:ext uri="{BB962C8B-B14F-4D97-AF65-F5344CB8AC3E}">
        <p14:creationId xmlns:p14="http://schemas.microsoft.com/office/powerpoint/2010/main" val="289013198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1" name="Tabel 10">
            <a:extLst>
              <a:ext uri="{FF2B5EF4-FFF2-40B4-BE49-F238E27FC236}">
                <a16:creationId xmlns:a16="http://schemas.microsoft.com/office/drawing/2014/main" id="{D5668FBC-CE0D-B54D-A56E-84112DD4B99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53557550"/>
              </p:ext>
            </p:extLst>
          </p:nvPr>
        </p:nvGraphicFramePr>
        <p:xfrm>
          <a:off x="133709" y="793628"/>
          <a:ext cx="6590581" cy="8833449"/>
        </p:xfrm>
        <a:graphic>
          <a:graphicData uri="http://schemas.openxmlformats.org/drawingml/2006/table">
            <a:tbl>
              <a:tblPr firstRow="1" firstCol="1" bandRow="1" bandCol="1"/>
              <a:tblGrid>
                <a:gridCol w="1686150">
                  <a:extLst>
                    <a:ext uri="{9D8B030D-6E8A-4147-A177-3AD203B41FA5}">
                      <a16:colId xmlns:a16="http://schemas.microsoft.com/office/drawing/2014/main" val="154918068"/>
                    </a:ext>
                  </a:extLst>
                </a:gridCol>
                <a:gridCol w="1135037">
                  <a:extLst>
                    <a:ext uri="{9D8B030D-6E8A-4147-A177-3AD203B41FA5}">
                      <a16:colId xmlns:a16="http://schemas.microsoft.com/office/drawing/2014/main" val="1106150102"/>
                    </a:ext>
                  </a:extLst>
                </a:gridCol>
                <a:gridCol w="569861">
                  <a:extLst>
                    <a:ext uri="{9D8B030D-6E8A-4147-A177-3AD203B41FA5}">
                      <a16:colId xmlns:a16="http://schemas.microsoft.com/office/drawing/2014/main" val="1461802851"/>
                    </a:ext>
                  </a:extLst>
                </a:gridCol>
                <a:gridCol w="1043966">
                  <a:extLst>
                    <a:ext uri="{9D8B030D-6E8A-4147-A177-3AD203B41FA5}">
                      <a16:colId xmlns:a16="http://schemas.microsoft.com/office/drawing/2014/main" val="3309513256"/>
                    </a:ext>
                  </a:extLst>
                </a:gridCol>
                <a:gridCol w="664281">
                  <a:extLst>
                    <a:ext uri="{9D8B030D-6E8A-4147-A177-3AD203B41FA5}">
                      <a16:colId xmlns:a16="http://schemas.microsoft.com/office/drawing/2014/main" val="3448982836"/>
                    </a:ext>
                  </a:extLst>
                </a:gridCol>
                <a:gridCol w="949547">
                  <a:extLst>
                    <a:ext uri="{9D8B030D-6E8A-4147-A177-3AD203B41FA5}">
                      <a16:colId xmlns:a16="http://schemas.microsoft.com/office/drawing/2014/main" val="2254746318"/>
                    </a:ext>
                  </a:extLst>
                </a:gridCol>
                <a:gridCol w="541739">
                  <a:extLst>
                    <a:ext uri="{9D8B030D-6E8A-4147-A177-3AD203B41FA5}">
                      <a16:colId xmlns:a16="http://schemas.microsoft.com/office/drawing/2014/main" val="1899352174"/>
                    </a:ext>
                  </a:extLst>
                </a:gridCol>
              </a:tblGrid>
              <a:tr h="588857">
                <a:tc gridSpan="7"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 b="1" dirty="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LGA SPM12</a:t>
                      </a:r>
                      <a:endParaRPr lang="da-DK" sz="1200" dirty="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 b="1" dirty="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% change WMH volume per 1m/s increase in PWV (95% CI)</a:t>
                      </a:r>
                      <a:endParaRPr lang="da-DK" sz="1200" dirty="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30805" marR="308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a-DK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a-DK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a-DK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a-DK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a-DK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a-DK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50292771"/>
                  </a:ext>
                </a:extLst>
              </a:tr>
              <a:tr h="588911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GB" sz="1200" b="1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 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30805" marR="308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All </a:t>
                      </a:r>
                      <a:endParaRPr lang="da-DK" sz="1200" dirty="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(n=104)</a:t>
                      </a:r>
                      <a:endParaRPr lang="da-DK" sz="1200" dirty="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30805" marR="308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p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30805" marR="308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DM 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(n=45)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30805" marR="308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p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30805" marR="308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Controls (n=59)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30805" marR="308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p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30805" marR="308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60905039"/>
                  </a:ext>
                </a:extLst>
              </a:tr>
              <a:tr h="588911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GB" sz="12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Crude 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30805" marR="308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24</a:t>
                      </a:r>
                      <a:endParaRPr lang="da-DK" sz="1200" dirty="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(13-35)</a:t>
                      </a:r>
                      <a:endParaRPr lang="da-DK" sz="1200" dirty="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30805" marR="308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&lt;0.01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30805" marR="308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21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(8-36)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30805" marR="308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&lt;0.01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30805" marR="308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30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(9-56)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30805" marR="308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&lt;0.01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30805" marR="308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02526527"/>
                  </a:ext>
                </a:extLst>
              </a:tr>
              <a:tr h="907720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GB" sz="12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Adjusted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30805" marR="308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11 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(2 – 22)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 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30805" marR="308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&lt;0.05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30805" marR="308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22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(7 - 39)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30805" marR="308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&lt;0.01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30805" marR="308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6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(-15 - 32)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30805" marR="308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0.59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30805" marR="308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438798"/>
                  </a:ext>
                </a:extLst>
              </a:tr>
              <a:tr h="270048">
                <a:tc gridSpan="7"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% change WMH volume if PWV &gt; 8.94m/s</a:t>
                      </a:r>
                      <a:endParaRPr lang="da-DK" sz="1200" dirty="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30805" marR="308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a-DK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a-DK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a-DK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a-DK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a-DK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a-DK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41688562"/>
                  </a:ext>
                </a:extLst>
              </a:tr>
              <a:tr h="588911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GB" sz="12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Crude 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30805" marR="308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127 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(52-339)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30805" marR="308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&lt;0.01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30805" marR="308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126 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(41-263)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30805" marR="308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&lt;0.01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30805" marR="308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125 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(26-303)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30805" marR="308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&lt;0.05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30805" marR="308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92090572"/>
                  </a:ext>
                </a:extLst>
              </a:tr>
              <a:tr h="588911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GB" sz="12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Adjusted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30805" marR="308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63 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(11-140)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30805" marR="308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&lt;0.05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30805" marR="308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105 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(24-238)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30805" marR="308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&lt;0.05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30805" marR="308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54 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(-14-178)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30805" marR="308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0.14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30805" marR="308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79580115"/>
                  </a:ext>
                </a:extLst>
              </a:tr>
              <a:tr h="588857">
                <a:tc gridSpan="7"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 b="1" dirty="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LPA SPM12</a:t>
                      </a:r>
                      <a:endParaRPr lang="da-DK" sz="1200" dirty="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 b="1" dirty="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% change WMH volume per 1m/s increase in PWV (95% CI)</a:t>
                      </a:r>
                      <a:endParaRPr lang="da-DK" sz="1200" dirty="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30805" marR="308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a-DK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a-DK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a-DK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a-DK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a-DK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a-DK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14308485"/>
                  </a:ext>
                </a:extLst>
              </a:tr>
              <a:tr h="588911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 b="1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 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30805" marR="308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All 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(n=104)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30805" marR="308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p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30805" marR="308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DM 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(n=45)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30805" marR="308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p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30805" marR="308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Controls (n=59)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30805" marR="308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p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30805" marR="308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39599579"/>
                  </a:ext>
                </a:extLst>
              </a:tr>
              <a:tr h="588911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Crude 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30805" marR="308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31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(20-44)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30805" marR="308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&lt;0.01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30805" marR="308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36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(18-56)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30805" marR="308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&lt;0.01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30805" marR="308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30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(5-62)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30805" marR="308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&lt;0.05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30805" marR="308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39050232"/>
                  </a:ext>
                </a:extLst>
              </a:tr>
              <a:tr h="907720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 b="1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Adjusted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30805" marR="308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12 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(-1 – 25)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 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30805" marR="308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0.08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30805" marR="308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18</a:t>
                      </a:r>
                      <a:endParaRPr lang="da-DK" sz="1200" dirty="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(-1 - 42)</a:t>
                      </a:r>
                      <a:endParaRPr lang="da-DK" sz="1200" dirty="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30805" marR="308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0.06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 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30805" marR="308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-2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(-25 - 28)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30805" marR="308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0.89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30805" marR="308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86901895"/>
                  </a:ext>
                </a:extLst>
              </a:tr>
              <a:tr h="270048">
                <a:tc gridSpan="7"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% change WMH volume if PWV &gt; 8.94m/s</a:t>
                      </a:r>
                      <a:endParaRPr lang="da-DK" sz="1200" dirty="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30805" marR="308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a-DK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a-DK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a-DK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a-DK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a-DK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a-DK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69045756"/>
                  </a:ext>
                </a:extLst>
              </a:tr>
              <a:tr h="588911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Crude 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30805" marR="308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191 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(77-380)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30805" marR="308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&lt;0.01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30805" marR="308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255 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(102-523)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30805" marR="308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&lt;0.01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30805" marR="308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153 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(27-404)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30805" marR="308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&lt;0.01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30805" marR="308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40735269"/>
                  </a:ext>
                </a:extLst>
              </a:tr>
              <a:tr h="588911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Adjusted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30805" marR="308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76 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(4-199)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30805" marR="308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&lt;0.05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30805" marR="308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98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 (0-291)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30805" marR="308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0.05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30805" marR="308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54 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(-25 – 217)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30805" marR="308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0.24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30805" marR="308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07948748"/>
                  </a:ext>
                </a:extLst>
              </a:tr>
              <a:tr h="588911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Adjusted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30805" marR="308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50 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(-11-153)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30805" marR="308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0.12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30805" marR="308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90 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(-32-434)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30805" marR="308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0.22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30805" marR="308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22 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(-13 – 70)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30805" marR="308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0.25</a:t>
                      </a:r>
                      <a:endParaRPr lang="da-DK" sz="1200" dirty="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30805" marR="308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87536055"/>
                  </a:ext>
                </a:extLst>
              </a:tr>
            </a:tbl>
          </a:graphicData>
        </a:graphic>
      </p:graphicFrame>
      <p:sp>
        <p:nvSpPr>
          <p:cNvPr id="12" name="Tekstfelt 11">
            <a:extLst>
              <a:ext uri="{FF2B5EF4-FFF2-40B4-BE49-F238E27FC236}">
                <a16:creationId xmlns:a16="http://schemas.microsoft.com/office/drawing/2014/main" id="{34D4372C-2927-824D-87CE-B91B2C18C8B7}"/>
              </a:ext>
            </a:extLst>
          </p:cNvPr>
          <p:cNvSpPr txBox="1"/>
          <p:nvPr/>
        </p:nvSpPr>
        <p:spPr>
          <a:xfrm>
            <a:off x="0" y="-138022"/>
            <a:ext cx="6755311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 </a:t>
            </a:r>
            <a:endParaRPr lang="da-DK" dirty="0"/>
          </a:p>
          <a:p>
            <a:r>
              <a:rPr lang="en-GB" b="1" dirty="0"/>
              <a:t>Supplementary Table 2. </a:t>
            </a:r>
            <a:endParaRPr lang="da-DK" dirty="0"/>
          </a:p>
          <a:p>
            <a:r>
              <a:rPr lang="en-GB" dirty="0"/>
              <a:t>Title: Pulse wave velocity and white matter hyperintensity progression</a:t>
            </a:r>
            <a:endParaRPr lang="da-DK" dirty="0"/>
          </a:p>
          <a:p>
            <a:endParaRPr lang="da-DK" dirty="0"/>
          </a:p>
        </p:txBody>
      </p:sp>
    </p:spTree>
    <p:extLst>
      <p:ext uri="{BB962C8B-B14F-4D97-AF65-F5344CB8AC3E}">
        <p14:creationId xmlns:p14="http://schemas.microsoft.com/office/powerpoint/2010/main" val="319159364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kstfelt 4">
            <a:extLst>
              <a:ext uri="{FF2B5EF4-FFF2-40B4-BE49-F238E27FC236}">
                <a16:creationId xmlns:a16="http://schemas.microsoft.com/office/drawing/2014/main" id="{897B7579-6C01-0241-B61F-A63BD87703AC}"/>
              </a:ext>
            </a:extLst>
          </p:cNvPr>
          <p:cNvSpPr txBox="1"/>
          <p:nvPr/>
        </p:nvSpPr>
        <p:spPr>
          <a:xfrm>
            <a:off x="204877" y="0"/>
            <a:ext cx="5962723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 </a:t>
            </a:r>
            <a:endParaRPr lang="da-DK" dirty="0"/>
          </a:p>
          <a:p>
            <a:r>
              <a:rPr lang="en-GB" b="1" dirty="0"/>
              <a:t>Supplementary Table 2 – cont. </a:t>
            </a:r>
            <a:endParaRPr lang="da-DK" dirty="0"/>
          </a:p>
          <a:p>
            <a:r>
              <a:rPr lang="en-GB" dirty="0"/>
              <a:t>Title: Pulse wave velocity and white matter lesion progression</a:t>
            </a:r>
            <a:endParaRPr lang="da-DK" dirty="0"/>
          </a:p>
          <a:p>
            <a:endParaRPr lang="da-DK" dirty="0"/>
          </a:p>
        </p:txBody>
      </p:sp>
      <p:sp>
        <p:nvSpPr>
          <p:cNvPr id="6" name="Tekstfelt 5">
            <a:extLst>
              <a:ext uri="{FF2B5EF4-FFF2-40B4-BE49-F238E27FC236}">
                <a16:creationId xmlns:a16="http://schemas.microsoft.com/office/drawing/2014/main" id="{516E9E5D-F3B6-3B40-AA88-4E5F58ECF664}"/>
              </a:ext>
            </a:extLst>
          </p:cNvPr>
          <p:cNvSpPr txBox="1"/>
          <p:nvPr/>
        </p:nvSpPr>
        <p:spPr>
          <a:xfrm>
            <a:off x="239668" y="6397347"/>
            <a:ext cx="5962724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Legend: </a:t>
            </a:r>
            <a:r>
              <a:rPr lang="en-GB" baseline="30000" dirty="0"/>
              <a:t>a</a:t>
            </a:r>
            <a:r>
              <a:rPr lang="en-GB" dirty="0"/>
              <a:t> Adjusted model 1: age, sex, diabetes status (yes/no),</a:t>
            </a:r>
          </a:p>
          <a:p>
            <a:r>
              <a:rPr lang="en-GB" dirty="0"/>
              <a:t> baseline pulse pressure and smoking status (no smoking or current/former smoking). In separate group analysis, diabetes status was omitted.</a:t>
            </a:r>
            <a:endParaRPr lang="da-DK" dirty="0"/>
          </a:p>
          <a:p>
            <a:r>
              <a:rPr lang="en-GB" dirty="0"/>
              <a:t>WMH = Cerebral white matter hyperintensities </a:t>
            </a:r>
            <a:endParaRPr lang="da-DK" dirty="0"/>
          </a:p>
          <a:p>
            <a:r>
              <a:rPr lang="en-GB" dirty="0"/>
              <a:t>PWV = Pulse wave velocity</a:t>
            </a:r>
            <a:endParaRPr lang="da-DK" dirty="0"/>
          </a:p>
          <a:p>
            <a:endParaRPr lang="da-DK" dirty="0"/>
          </a:p>
        </p:txBody>
      </p:sp>
      <p:graphicFrame>
        <p:nvGraphicFramePr>
          <p:cNvPr id="9" name="Tabel 8">
            <a:extLst>
              <a:ext uri="{FF2B5EF4-FFF2-40B4-BE49-F238E27FC236}">
                <a16:creationId xmlns:a16="http://schemas.microsoft.com/office/drawing/2014/main" id="{9BBEBBBE-80B1-CE41-A1F6-E3D86C0AA42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86415032"/>
              </p:ext>
            </p:extLst>
          </p:nvPr>
        </p:nvGraphicFramePr>
        <p:xfrm>
          <a:off x="239668" y="1200329"/>
          <a:ext cx="6172200" cy="5094799"/>
        </p:xfrm>
        <a:graphic>
          <a:graphicData uri="http://schemas.openxmlformats.org/drawingml/2006/table">
            <a:tbl>
              <a:tblPr firstRow="1" firstCol="1" bandRow="1" bandCol="1"/>
              <a:tblGrid>
                <a:gridCol w="1579110">
                  <a:extLst>
                    <a:ext uri="{9D8B030D-6E8A-4147-A177-3AD203B41FA5}">
                      <a16:colId xmlns:a16="http://schemas.microsoft.com/office/drawing/2014/main" val="2265627032"/>
                    </a:ext>
                  </a:extLst>
                </a:gridCol>
                <a:gridCol w="1062983">
                  <a:extLst>
                    <a:ext uri="{9D8B030D-6E8A-4147-A177-3AD203B41FA5}">
                      <a16:colId xmlns:a16="http://schemas.microsoft.com/office/drawing/2014/main" val="1724678739"/>
                    </a:ext>
                  </a:extLst>
                </a:gridCol>
                <a:gridCol w="533687">
                  <a:extLst>
                    <a:ext uri="{9D8B030D-6E8A-4147-A177-3AD203B41FA5}">
                      <a16:colId xmlns:a16="http://schemas.microsoft.com/office/drawing/2014/main" val="570846042"/>
                    </a:ext>
                  </a:extLst>
                </a:gridCol>
                <a:gridCol w="977694">
                  <a:extLst>
                    <a:ext uri="{9D8B030D-6E8A-4147-A177-3AD203B41FA5}">
                      <a16:colId xmlns:a16="http://schemas.microsoft.com/office/drawing/2014/main" val="3193078501"/>
                    </a:ext>
                  </a:extLst>
                </a:gridCol>
                <a:gridCol w="622111">
                  <a:extLst>
                    <a:ext uri="{9D8B030D-6E8A-4147-A177-3AD203B41FA5}">
                      <a16:colId xmlns:a16="http://schemas.microsoft.com/office/drawing/2014/main" val="894862127"/>
                    </a:ext>
                  </a:extLst>
                </a:gridCol>
                <a:gridCol w="889268">
                  <a:extLst>
                    <a:ext uri="{9D8B030D-6E8A-4147-A177-3AD203B41FA5}">
                      <a16:colId xmlns:a16="http://schemas.microsoft.com/office/drawing/2014/main" val="792810947"/>
                    </a:ext>
                  </a:extLst>
                </a:gridCol>
                <a:gridCol w="507347">
                  <a:extLst>
                    <a:ext uri="{9D8B030D-6E8A-4147-A177-3AD203B41FA5}">
                      <a16:colId xmlns:a16="http://schemas.microsoft.com/office/drawing/2014/main" val="3070890870"/>
                    </a:ext>
                  </a:extLst>
                </a:gridCol>
              </a:tblGrid>
              <a:tr h="666322">
                <a:tc gridSpan="7"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GB" sz="1200" b="1" dirty="0" err="1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Freesurfer</a:t>
                      </a:r>
                      <a:endParaRPr lang="da-DK" sz="1200" dirty="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GB" sz="1200" b="1" dirty="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% change WMH volume per 1m/s increase in PWV (95% CI)</a:t>
                      </a:r>
                      <a:endParaRPr lang="da-DK" sz="1200" dirty="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67641" marR="676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a-DK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a-DK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a-DK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a-DK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a-DK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a-DK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30301547"/>
                  </a:ext>
                </a:extLst>
              </a:tr>
              <a:tr h="666385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GB" sz="1200" b="1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 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67641" marR="676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All </a:t>
                      </a:r>
                      <a:endParaRPr lang="da-DK" sz="1200" dirty="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(n=104)</a:t>
                      </a:r>
                      <a:endParaRPr lang="da-DK" sz="1200" dirty="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67641" marR="676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p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67641" marR="676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DM 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(n=45)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67641" marR="676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p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67641" marR="676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Controls (n=59)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67641" marR="676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p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67641" marR="676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04955955"/>
                  </a:ext>
                </a:extLst>
              </a:tr>
              <a:tr h="102713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GB" sz="12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Crude 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67641" marR="676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9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(1-18)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67641" marR="676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&lt;0.05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67641" marR="676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16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(-2 - 38)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67641" marR="676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0.08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67641" marR="676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5 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(-4 – 14)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2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 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67641" marR="676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0.27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67641" marR="676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73214431"/>
                  </a:ext>
                </a:extLst>
              </a:tr>
              <a:tr h="102713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GB" sz="12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Adjusted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67641" marR="676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13 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(-7 – 37)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 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67641" marR="676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0.22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67641" marR="676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20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(-11 - 62)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67641" marR="676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0.22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 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67641" marR="676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1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(-7 - 10)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67641" marR="676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0.84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67641" marR="676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10935769"/>
                  </a:ext>
                </a:extLst>
              </a:tr>
              <a:tr h="305573">
                <a:tc gridSpan="7"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GB" sz="12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% change WMH volume if PWV &gt; 8.94m/s</a:t>
                      </a:r>
                      <a:endParaRPr lang="da-DK" sz="1200" dirty="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67641" marR="676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a-DK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a-DK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a-DK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a-DK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a-DK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a-DK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48349859"/>
                  </a:ext>
                </a:extLst>
              </a:tr>
              <a:tr h="666385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GB" sz="12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Crude 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67641" marR="676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45 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(8-95)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67641" marR="676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&lt;0.05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67641" marR="676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80 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(-5 – 241)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67641" marR="676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0.07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67641" marR="676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29 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(-10 – 83)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67641" marR="676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0.16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67641" marR="676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08110690"/>
                  </a:ext>
                </a:extLst>
              </a:tr>
              <a:tr h="666385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GB" sz="12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Adjusted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67641" marR="676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50 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(-11-153)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67641" marR="676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0.12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67641" marR="676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90 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(-32-434)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67641" marR="676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0.22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67641" marR="676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22 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(-13 – 70)</a:t>
                      </a:r>
                      <a:endParaRPr lang="da-DK" sz="120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67641" marR="676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ea typeface="MS ??"/>
                          <a:cs typeface="Times New Roman" panose="02020603050405020304" pitchFamily="18" charset="0"/>
                        </a:rPr>
                        <a:t>0.25</a:t>
                      </a:r>
                      <a:endParaRPr lang="da-DK" sz="1200" dirty="0">
                        <a:effectLst/>
                        <a:latin typeface="Cambria" panose="02040503050406030204" pitchFamily="18" charset="0"/>
                        <a:ea typeface="MS ??"/>
                        <a:cs typeface="Times New Roman" panose="02020603050405020304" pitchFamily="18" charset="0"/>
                      </a:endParaRPr>
                    </a:p>
                  </a:txBody>
                  <a:tcPr marL="67641" marR="676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6536747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762823781"/>
      </p:ext>
    </p:extLst>
  </p:cSld>
  <p:clrMapOvr>
    <a:masterClrMapping/>
  </p:clrMapOvr>
</p:sld>
</file>

<file path=ppt/theme/theme1.xml><?xml version="1.0" encoding="utf-8"?>
<a:theme xmlns:a="http://schemas.openxmlformats.org/drawingml/2006/main" name="Kontortema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814</TotalTime>
  <Words>698</Words>
  <Application>Microsoft Macintosh PowerPoint</Application>
  <PresentationFormat>A4-papir (210 x 297 mm)</PresentationFormat>
  <Paragraphs>222</Paragraphs>
  <Slides>5</Slides>
  <Notes>0</Notes>
  <HiddenSlides>0</HiddenSlides>
  <MMClips>0</MMClips>
  <ScaleCrop>false</ScaleCrop>
  <HeadingPairs>
    <vt:vector size="6" baseType="variant">
      <vt:variant>
        <vt:lpstr>Benyttede skrifttyper</vt:lpstr>
      </vt:variant>
      <vt:variant>
        <vt:i4>5</vt:i4>
      </vt:variant>
      <vt:variant>
        <vt:lpstr>Tema</vt:lpstr>
      </vt:variant>
      <vt:variant>
        <vt:i4>1</vt:i4>
      </vt:variant>
      <vt:variant>
        <vt:lpstr>Slidetitler</vt:lpstr>
      </vt:variant>
      <vt:variant>
        <vt:i4>5</vt:i4>
      </vt:variant>
    </vt:vector>
  </HeadingPairs>
  <TitlesOfParts>
    <vt:vector size="11" baseType="lpstr">
      <vt:lpstr>Arial</vt:lpstr>
      <vt:lpstr>Calibri</vt:lpstr>
      <vt:lpstr>Cambria</vt:lpstr>
      <vt:lpstr>Times New Roman</vt:lpstr>
      <vt:lpstr>Wingdings</vt:lpstr>
      <vt:lpstr>Kontortema</vt:lpstr>
      <vt:lpstr>PowerPoint-præsentation</vt:lpstr>
      <vt:lpstr>PowerPoint-præsentation</vt:lpstr>
      <vt:lpstr>PowerPoint-præsentation</vt:lpstr>
      <vt:lpstr>PowerPoint-præsentation</vt:lpstr>
      <vt:lpstr>PowerPoint-præ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æsentation</dc:title>
  <dc:creator>Kristian Løkke Funck</dc:creator>
  <cp:lastModifiedBy>Kristian Løkke Funck</cp:lastModifiedBy>
  <cp:revision>24</cp:revision>
  <cp:lastPrinted>2016-11-17T22:20:24Z</cp:lastPrinted>
  <dcterms:created xsi:type="dcterms:W3CDTF">2016-10-04T11:20:49Z</dcterms:created>
  <dcterms:modified xsi:type="dcterms:W3CDTF">2021-04-15T09:53:51Z</dcterms:modified>
</cp:coreProperties>
</file>